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6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787"/>
  </p:normalViewPr>
  <p:slideViewPr>
    <p:cSldViewPr snapToGrid="0" snapToObjects="1">
      <p:cViewPr varScale="1">
        <p:scale>
          <a:sx n="61" d="100"/>
          <a:sy n="61" d="100"/>
        </p:scale>
        <p:origin x="78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7F503C-F026-4824-B4C2-FDCBBC8B4DF7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 smtClean="0"/>
              <a:t>Rediger typografien i masterens</a:t>
            </a:r>
          </a:p>
          <a:p>
            <a:pPr lvl="1"/>
            <a:r>
              <a:rPr lang="da-DK" smtClean="0"/>
              <a:t>Andet niveau</a:t>
            </a:r>
          </a:p>
          <a:p>
            <a:pPr lvl="2"/>
            <a:r>
              <a:rPr lang="da-DK" smtClean="0"/>
              <a:t>Tredje niveau</a:t>
            </a:r>
          </a:p>
          <a:p>
            <a:pPr lvl="3"/>
            <a:r>
              <a:rPr lang="da-DK" smtClean="0"/>
              <a:t>Fjerde niveau</a:t>
            </a:r>
          </a:p>
          <a:p>
            <a:pPr lvl="4"/>
            <a:r>
              <a:rPr lang="da-DK" smtClean="0"/>
              <a:t>Femte niveau</a:t>
            </a:r>
            <a:endParaRPr lang="en-GB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FBACF09-E2EB-4485-BDCC-D06CCB0BF2D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64315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BACF09-E2EB-4485-BDCC-D06CCB0BF2D3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75166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BACF09-E2EB-4485-BDCC-D06CCB0BF2D3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49664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BACF09-E2EB-4485-BDCC-D06CCB0BF2D3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11378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BACF09-E2EB-4485-BDCC-D06CCB0BF2D3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9701753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BACF09-E2EB-4485-BDCC-D06CCB0BF2D3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980846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BACF09-E2EB-4485-BDCC-D06CCB0BF2D3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927284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BACF09-E2EB-4485-BDCC-D06CCB0BF2D3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813324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lidebille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FBACF09-E2EB-4485-BDCC-D06CCB0BF2D3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97173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6699BD-5A09-6A47-A6FD-607D9E4D055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3402E92-3E41-FC44-8729-6A720B84C6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80FC13-9B63-8848-8855-A8341F8058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801C79-308B-5A45-A9D8-2E36EBBEEE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F54F35-E47E-D64F-90FB-578BCB7BEB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54314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1A56BE-6E2A-E946-A5F1-6713BCCF3E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875E42-9FF0-114D-8201-591AF61649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43B513-8136-724E-8EBD-CF81353C64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48FB6C-CEFE-6C44-A427-A4650BD11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A32243-5419-824B-AD50-A7C9CF949A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0645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D40DFB-88C2-2D46-9D8F-91736C40B6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B7C5FE-D51F-4B43-8311-A1FC9BA6BC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02F504-62F5-BB46-B8B5-A1A0DDA76B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3BC9B6-B494-EC41-895B-1BC468DF1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FCA4DF-A0F9-D444-8078-A1ED0A079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3279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77414B-7E3E-214E-A771-328C8B5069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860588-5146-0349-B86B-3316117F1A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955470-5C77-A44E-A52F-D4D63AC8C2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2BBAC1-802A-D34B-AFDE-FEAE03559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488353-D4BC-1040-84AC-6A85F07BC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5684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23D431-6321-A143-8B58-59B2F99EB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59BD620-6D38-FA4B-B218-D3CFB954D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42E5E5-725C-5140-83BD-63559FFC7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417D59-A6A6-3647-9E4C-50D018393F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34366B-FBF8-B146-965A-F3B576938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93315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9497B4-F5A9-954C-AFD3-B56FD3C184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7150133-F0EC-EA4A-9907-92534B1653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725B68-A6A4-2E4D-823F-B975519282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09E3ED-1077-FF43-810C-B24BA218D4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F82777-C0E4-CB40-86BF-814ABA40DA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AF83AF-CDF4-CD4C-9C4A-F0D1A92FB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481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063B8-7027-A545-A9CF-B85D814463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87FBC2-75C2-B445-8935-742EE77E3A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4B7CC29-EAE1-A741-A1B7-A4AD234D05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4A65D6F-3B1E-6E44-855E-0EF863CA37E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4A21E9C-E4BB-9B47-A5FA-4E036C29AC5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548528-5FA2-DF42-B586-CF3050F033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00D1308-0EA9-074C-824F-827B629A98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FFE4542-1097-604E-955D-613242FDE7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1648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BA7C22-9409-9240-BD1C-5BCCA16742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A82E5F-8A0D-A648-BE7B-3E152373E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35BD71D-2B24-D845-967E-4C2B75D4E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2C3EFA2-E9EC-3548-9626-4E2F580B0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60376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2FEE47-4F0C-8A48-A7F8-BFDED16235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A40D2D7-924A-9A47-8A6D-2FBF8CC4CD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377932-FD34-684B-8416-0CE7B4F3BB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0848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5C8DB4-F222-774C-B3F2-4DA756E0E4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11EC74-C3A4-2048-9AF2-F937AFBD5E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14A3909-846A-1B40-9687-CED611FAF78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FD94E1-ED43-D84C-AFBB-51A16570F2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6A385B-533D-BD49-AA32-A26D736DF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239531-41E7-8645-99B4-A9ECDB890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150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20A7D1-BA21-5042-B415-D037E4B81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C3401DC-039E-FC4E-A0BA-9009686D9D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942123-3632-BC4C-92F8-90DF5CBB0F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3BA140-4578-7543-A719-23AB8D2AD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CF4C7C-F4C7-D643-9998-76B820614F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0496408-B688-DC45-88A1-13E7445D8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9311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0B2389-09F9-1047-8F6B-D669701473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433F05-0B60-2340-A3A4-E76A4BB28E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8AFB2D-635C-7043-A75C-F92B99587AD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379399-B3B6-4A41-B4E3-350B28E08C22}" type="datetimeFigureOut">
              <a:rPr lang="en-GB" smtClean="0"/>
              <a:t>16/08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3EE240-F098-E340-844B-350E237805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783886-E388-F343-B6D0-621D108B5B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810C63-C199-F34A-8B5D-656579F4B5FB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76532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7">
            <a:extLst>
              <a:ext uri="{FF2B5EF4-FFF2-40B4-BE49-F238E27FC236}">
                <a16:creationId xmlns:a16="http://schemas.microsoft.com/office/drawing/2014/main" id="{61592385-BA90-1842-82F5-A5D56A962EC5}"/>
              </a:ext>
            </a:extLst>
          </p:cNvPr>
          <p:cNvSpPr txBox="1">
            <a:spLocks/>
          </p:cNvSpPr>
          <p:nvPr/>
        </p:nvSpPr>
        <p:spPr>
          <a:xfrm>
            <a:off x="648930" y="2438400"/>
            <a:ext cx="4944151" cy="37854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1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2400"/>
              <a:t>Relative change in HbA1c in % after intervention in vehicle (cont) and liraglutide (lira) treated groups compared before and after intervention with liraglutide. 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2400"/>
              <a:t>Statistical analysis: one-way ANOVA with Turkey´s post hoc. </a:t>
            </a:r>
          </a:p>
          <a:p>
            <a:pPr marL="228600" indent="-228600">
              <a:buFont typeface="Arial" panose="020B0604020202020204" pitchFamily="34" charset="0"/>
              <a:buChar char="•"/>
            </a:pPr>
            <a:r>
              <a:rPr lang="en-US" sz="2400"/>
              <a:t>All data are shown as mean </a:t>
            </a:r>
            <a:r>
              <a:rPr lang="en-US" sz="2400">
                <a:sym typeface="Symbol" pitchFamily="2" charset="2"/>
              </a:rPr>
              <a:t></a:t>
            </a:r>
            <a:r>
              <a:rPr lang="en-US" sz="2400"/>
              <a:t> SEM. 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6F7435D-E3DB-47B1-BA61-B00ACC83A9DE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92950" y="0"/>
            <a:ext cx="6099050" cy="6858000"/>
          </a:xfrm>
          <a:prstGeom prst="rect">
            <a:avLst/>
          </a:prstGeom>
          <a:solidFill>
            <a:srgbClr val="C8CAC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ounded Rectangle 9">
            <a:extLst>
              <a:ext uri="{FF2B5EF4-FFF2-40B4-BE49-F238E27FC236}">
                <a16:creationId xmlns:a16="http://schemas.microsoft.com/office/drawing/2014/main" id="{F263A0B5-F8C4-4116-809F-78A768EA79A6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577582" y="557784"/>
            <a:ext cx="5130204" cy="5739187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116EFDE-8934-A34D-8B97-8F3CA7F014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04709" y="1353636"/>
            <a:ext cx="4475531" cy="4147481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26421640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7">
            <a:extLst>
              <a:ext uri="{FF2B5EF4-FFF2-40B4-BE49-F238E27FC236}">
                <a16:creationId xmlns:a16="http://schemas.microsoft.com/office/drawing/2014/main" id="{8ECFF330-2F69-174E-B724-75B138CF0210}"/>
              </a:ext>
            </a:extLst>
          </p:cNvPr>
          <p:cNvSpPr txBox="1">
            <a:spLocks/>
          </p:cNvSpPr>
          <p:nvPr/>
        </p:nvSpPr>
        <p:spPr>
          <a:xfrm>
            <a:off x="648930" y="2438400"/>
            <a:ext cx="4944151" cy="37854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2200"/>
          </a:p>
          <a:p>
            <a:r>
              <a:rPr lang="en-US" sz="2200"/>
              <a:t>HbA1c levels in liraglutide treated groups before and after intervention.</a:t>
            </a:r>
            <a:r>
              <a:rPr lang="en-US" sz="2200" b="1"/>
              <a:t> </a:t>
            </a:r>
          </a:p>
          <a:p>
            <a:r>
              <a:rPr lang="en-US" sz="2200"/>
              <a:t>Statistical analysis: </a:t>
            </a:r>
          </a:p>
          <a:p>
            <a:r>
              <a:rPr lang="en-US" sz="2200"/>
              <a:t>B6NRj:  paired t-test.</a:t>
            </a:r>
          </a:p>
          <a:p>
            <a:r>
              <a:rPr lang="en-US" sz="2200"/>
              <a:t>B6NTac: Wilcoxon matched-pairs signed rank test. </a:t>
            </a:r>
          </a:p>
          <a:p>
            <a:r>
              <a:rPr lang="en-US" sz="2200"/>
              <a:t>All data are shown as mean </a:t>
            </a:r>
            <a:r>
              <a:rPr lang="en-US" sz="2200">
                <a:sym typeface="Symbol" pitchFamily="2" charset="2"/>
              </a:rPr>
              <a:t></a:t>
            </a:r>
            <a:r>
              <a:rPr lang="en-US" sz="2200"/>
              <a:t> SEM. </a:t>
            </a:r>
          </a:p>
          <a:p>
            <a:r>
              <a:rPr lang="en-US" sz="2200"/>
              <a:t>Differences denoted with ** p&lt;0.01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46F7435D-E3DB-47B1-BA61-B00ACC83A9DE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92950" y="0"/>
            <a:ext cx="6099050" cy="6858000"/>
          </a:xfrm>
          <a:prstGeom prst="rect">
            <a:avLst/>
          </a:prstGeom>
          <a:solidFill>
            <a:srgbClr val="C8CAC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ounded Rectangle 9">
            <a:extLst>
              <a:ext uri="{FF2B5EF4-FFF2-40B4-BE49-F238E27FC236}">
                <a16:creationId xmlns:a16="http://schemas.microsoft.com/office/drawing/2014/main" id="{F263A0B5-F8C4-4116-809F-78A768EA79A6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577582" y="557784"/>
            <a:ext cx="5130204" cy="5739187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Content Placeholder 9">
            <a:extLst>
              <a:ext uri="{FF2B5EF4-FFF2-40B4-BE49-F238E27FC236}">
                <a16:creationId xmlns:a16="http://schemas.microsoft.com/office/drawing/2014/main" id="{344D451E-93D6-624D-9307-7F3EF3C6174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6904709" y="1314593"/>
            <a:ext cx="4475531" cy="4225567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16130182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7">
            <a:extLst>
              <a:ext uri="{FF2B5EF4-FFF2-40B4-BE49-F238E27FC236}">
                <a16:creationId xmlns:a16="http://schemas.microsoft.com/office/drawing/2014/main" id="{716E99F9-71E0-AF49-AEBA-D58F7C1F7F32}"/>
              </a:ext>
            </a:extLst>
          </p:cNvPr>
          <p:cNvSpPr txBox="1">
            <a:spLocks/>
          </p:cNvSpPr>
          <p:nvPr/>
        </p:nvSpPr>
        <p:spPr>
          <a:xfrm>
            <a:off x="648930" y="2438400"/>
            <a:ext cx="4944151" cy="37854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2000"/>
          </a:p>
          <a:p>
            <a:r>
              <a:rPr lang="en-US" sz="2000"/>
              <a:t>Relative change in area under curve (AUC) of oral glucose tolerance test (OGTT) in % in vehicle (cont) and liraglutide (lira) treated groups compared before and after intervention with liraglutide.</a:t>
            </a:r>
          </a:p>
          <a:p>
            <a:r>
              <a:rPr lang="en-US" sz="2000"/>
              <a:t>All data are shown as mean </a:t>
            </a:r>
            <a:r>
              <a:rPr lang="en-US" sz="2000">
                <a:sym typeface="Symbol" pitchFamily="2" charset="2"/>
              </a:rPr>
              <a:t></a:t>
            </a:r>
            <a:r>
              <a:rPr lang="en-US" sz="2000"/>
              <a:t> SEM. </a:t>
            </a:r>
          </a:p>
          <a:p>
            <a:r>
              <a:rPr lang="en-US" sz="2000"/>
              <a:t>Statistical analysis: one-way ANOVA with Tukey’s post hoc. Differences denoted with * p&lt;0.05 ** p&lt;0.01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6F7435D-E3DB-47B1-BA61-B00ACC83A9DE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92950" y="0"/>
            <a:ext cx="6099050" cy="6858000"/>
          </a:xfrm>
          <a:prstGeom prst="rect">
            <a:avLst/>
          </a:prstGeom>
          <a:solidFill>
            <a:srgbClr val="C8CAC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ounded Rectangle 9">
            <a:extLst>
              <a:ext uri="{FF2B5EF4-FFF2-40B4-BE49-F238E27FC236}">
                <a16:creationId xmlns:a16="http://schemas.microsoft.com/office/drawing/2014/main" id="{F263A0B5-F8C4-4116-809F-78A768EA79A6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577582" y="557784"/>
            <a:ext cx="5130204" cy="5739187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B733513-E388-4D40-97B4-69C06034119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6904709" y="1363081"/>
            <a:ext cx="4475531" cy="4128590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11245101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22169D9A-6939-9548-B812-4B365346D371}"/>
              </a:ext>
            </a:extLst>
          </p:cNvPr>
          <p:cNvSpPr/>
          <p:nvPr/>
        </p:nvSpPr>
        <p:spPr>
          <a:xfrm>
            <a:off x="648930" y="2438400"/>
            <a:ext cx="4944151" cy="37854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000"/>
              <a:t>Oral glucose tolerance test (OGTT) after intervention with liraglutide in vehicle (cont) and liraglutide (lira) treated groups. Fasting blood glucose measurement at t=0 and subsequent blood glucose measurements at 15 to 120 minutes after oral glucose challenge.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000"/>
              <a:t>Statistical analysis: repeated measurements two-way ANOVA with Turkey´s post hoc and factors “treatment” and “time”.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000"/>
              <a:t>All data are shown as mean </a:t>
            </a:r>
            <a:r>
              <a:rPr lang="en-US" sz="2000">
                <a:sym typeface="Symbol" pitchFamily="2" charset="2"/>
              </a:rPr>
              <a:t></a:t>
            </a:r>
            <a:r>
              <a:rPr lang="en-US" sz="2000"/>
              <a:t> SEM. 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endParaRPr lang="en-US" sz="200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6F7435D-E3DB-47B1-BA61-B00ACC83A9DE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92950" y="0"/>
            <a:ext cx="6099050" cy="6858000"/>
          </a:xfrm>
          <a:prstGeom prst="rect">
            <a:avLst/>
          </a:prstGeom>
          <a:solidFill>
            <a:srgbClr val="C8CAC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ounded Rectangle 9">
            <a:extLst>
              <a:ext uri="{FF2B5EF4-FFF2-40B4-BE49-F238E27FC236}">
                <a16:creationId xmlns:a16="http://schemas.microsoft.com/office/drawing/2014/main" id="{F263A0B5-F8C4-4116-809F-78A768EA79A6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577582" y="557784"/>
            <a:ext cx="5130204" cy="5739187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206F237D-2813-8643-B8D8-0C4D5222866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6904709" y="2111261"/>
            <a:ext cx="4475531" cy="2632231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38706366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Placeholder 7">
            <a:extLst>
              <a:ext uri="{FF2B5EF4-FFF2-40B4-BE49-F238E27FC236}">
                <a16:creationId xmlns:a16="http://schemas.microsoft.com/office/drawing/2014/main" id="{FC7812A8-B91B-FC42-A9FE-21AD66EE75AE}"/>
              </a:ext>
            </a:extLst>
          </p:cNvPr>
          <p:cNvSpPr txBox="1">
            <a:spLocks/>
          </p:cNvSpPr>
          <p:nvPr/>
        </p:nvSpPr>
        <p:spPr>
          <a:xfrm>
            <a:off x="648930" y="2438400"/>
            <a:ext cx="4944151" cy="37854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en-US" sz="2000"/>
          </a:p>
          <a:p>
            <a:r>
              <a:rPr lang="en-US" sz="2000"/>
              <a:t>Relative change in body weight in % during intervention with liraglutide in vehicle (cont) and liraglutide (lira) treated groups. </a:t>
            </a:r>
          </a:p>
          <a:p>
            <a:r>
              <a:rPr lang="en-US" sz="2000"/>
              <a:t>Statistical analysis: Brown-Forsythe and Welch ANOVA test with Dunnett´s T3 post hoc.</a:t>
            </a:r>
          </a:p>
          <a:p>
            <a:r>
              <a:rPr lang="en-US" sz="2000"/>
              <a:t>All data are shown as mean </a:t>
            </a:r>
            <a:r>
              <a:rPr lang="en-US" sz="2000">
                <a:sym typeface="Symbol" pitchFamily="2" charset="2"/>
              </a:rPr>
              <a:t></a:t>
            </a:r>
            <a:r>
              <a:rPr lang="en-US" sz="2000"/>
              <a:t> SEM.</a:t>
            </a:r>
          </a:p>
          <a:p>
            <a:r>
              <a:rPr lang="en-US" sz="2000"/>
              <a:t> Differences denoted with **** p&lt;0.0001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46F7435D-E3DB-47B1-BA61-B00ACC83A9DE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92950" y="0"/>
            <a:ext cx="6099050" cy="6858000"/>
          </a:xfrm>
          <a:prstGeom prst="rect">
            <a:avLst/>
          </a:prstGeom>
          <a:solidFill>
            <a:srgbClr val="C8CAC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ounded Rectangle 9">
            <a:extLst>
              <a:ext uri="{FF2B5EF4-FFF2-40B4-BE49-F238E27FC236}">
                <a16:creationId xmlns:a16="http://schemas.microsoft.com/office/drawing/2014/main" id="{F263A0B5-F8C4-4116-809F-78A768EA79A6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577582" y="557784"/>
            <a:ext cx="5130204" cy="5739187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99AD157C-4ED7-334D-9016-914D960D88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04709" y="1360838"/>
            <a:ext cx="4475531" cy="4133076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15889634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693BCBFB-9550-5A49-9384-9616F1323383}"/>
              </a:ext>
            </a:extLst>
          </p:cNvPr>
          <p:cNvSpPr/>
          <p:nvPr/>
        </p:nvSpPr>
        <p:spPr>
          <a:xfrm>
            <a:off x="648930" y="2438400"/>
            <a:ext cx="4944151" cy="37854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Fasting serum insulin (pg/ml) in vehicle (cont) and liraglutide (lira) treated groups after intervention with liraglutide. 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Statistical analysis: Kruskal-Wallis test with Dunn’s post hoc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All data are shown as mean </a:t>
            </a:r>
            <a:r>
              <a:rPr lang="en-US" sz="2400">
                <a:sym typeface="Symbol" pitchFamily="2" charset="2"/>
              </a:rPr>
              <a:t></a:t>
            </a:r>
            <a:r>
              <a:rPr lang="en-US" sz="2400"/>
              <a:t> SEM.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Differences denoted with *** p&lt;0.001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endParaRPr lang="en-US" sz="240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6F7435D-E3DB-47B1-BA61-B00ACC83A9DE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92950" y="0"/>
            <a:ext cx="6099050" cy="6858000"/>
          </a:xfrm>
          <a:prstGeom prst="rect">
            <a:avLst/>
          </a:prstGeom>
          <a:solidFill>
            <a:srgbClr val="C8CAC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ounded Rectangle 9">
            <a:extLst>
              <a:ext uri="{FF2B5EF4-FFF2-40B4-BE49-F238E27FC236}">
                <a16:creationId xmlns:a16="http://schemas.microsoft.com/office/drawing/2014/main" id="{F263A0B5-F8C4-4116-809F-78A768EA79A6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577582" y="557784"/>
            <a:ext cx="5130204" cy="5739187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584948E-2560-714B-8B67-B49635628F7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6904709" y="1703280"/>
            <a:ext cx="4475531" cy="3448193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16317455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CA544BCB-FE75-F940-B226-812ECF9B56B7}"/>
              </a:ext>
            </a:extLst>
          </p:cNvPr>
          <p:cNvSpPr/>
          <p:nvPr/>
        </p:nvSpPr>
        <p:spPr>
          <a:xfrm>
            <a:off x="648930" y="2438400"/>
            <a:ext cx="4944151" cy="37854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Fasting serum leptin (pg/ml) in vehicle (cont) and liraglutide (lira) treated groups after intervention with liraglutide. 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Statistical analysis: Brown-Forsythe and Welch ANOVA test with Dunnett´s T3 post hoc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All data are shown as mean </a:t>
            </a:r>
            <a:r>
              <a:rPr lang="en-US" sz="2400">
                <a:sym typeface="Symbol" pitchFamily="2" charset="2"/>
              </a:rPr>
              <a:t></a:t>
            </a:r>
            <a:r>
              <a:rPr lang="en-US" sz="2400"/>
              <a:t> SEM.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Differences denoted with * p&lt;0.05, *** p&lt;0.001, **** p&lt;0.0001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6F7435D-E3DB-47B1-BA61-B00ACC83A9DE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92950" y="0"/>
            <a:ext cx="6099050" cy="6858000"/>
          </a:xfrm>
          <a:prstGeom prst="rect">
            <a:avLst/>
          </a:prstGeom>
          <a:solidFill>
            <a:srgbClr val="C8CAC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ounded Rectangle 9">
            <a:extLst>
              <a:ext uri="{FF2B5EF4-FFF2-40B4-BE49-F238E27FC236}">
                <a16:creationId xmlns:a16="http://schemas.microsoft.com/office/drawing/2014/main" id="{F263A0B5-F8C4-4116-809F-78A768EA79A6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577582" y="557784"/>
            <a:ext cx="5130204" cy="5739187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BBE4DE49-14F2-1A45-8B21-BEC0341C4BF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6904709" y="1474327"/>
            <a:ext cx="4475531" cy="3906099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293525028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>
            <a:extLst>
              <a:ext uri="{FF2B5EF4-FFF2-40B4-BE49-F238E27FC236}">
                <a16:creationId xmlns:a16="http://schemas.microsoft.com/office/drawing/2014/main" id="{776812ED-890C-5E48-BC38-C4E8E173D38D}"/>
              </a:ext>
            </a:extLst>
          </p:cNvPr>
          <p:cNvSpPr/>
          <p:nvPr/>
        </p:nvSpPr>
        <p:spPr>
          <a:xfrm>
            <a:off x="648930" y="2438400"/>
            <a:ext cx="4944151" cy="37854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Fasting blood glucose (mmol/l) in vehicle (cont) and liraglutide (lira) treated groups after intervention with liraglutide taken under oral glucose tolerance test (OGTT). 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Statistical analysis: Kruskal-Wallis test with Dunn’s post hoc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All data are shown as mean </a:t>
            </a:r>
            <a:r>
              <a:rPr lang="en-US" sz="2400">
                <a:sym typeface="Symbol" pitchFamily="2" charset="2"/>
              </a:rPr>
              <a:t></a:t>
            </a:r>
            <a:r>
              <a:rPr lang="en-US" sz="2400"/>
              <a:t> SEM.</a:t>
            </a:r>
          </a:p>
          <a:p>
            <a:pPr marL="228600" indent="-228600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</a:pPr>
            <a:r>
              <a:rPr lang="en-US" sz="2400"/>
              <a:t>Differences denoted with ** p&lt;0.01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46F7435D-E3DB-47B1-BA61-B00ACC83A9DE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092950" y="0"/>
            <a:ext cx="6099050" cy="6858000"/>
          </a:xfrm>
          <a:prstGeom prst="rect">
            <a:avLst/>
          </a:prstGeom>
          <a:solidFill>
            <a:srgbClr val="C8CAC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ounded Rectangle 9">
            <a:extLst>
              <a:ext uri="{FF2B5EF4-FFF2-40B4-BE49-F238E27FC236}">
                <a16:creationId xmlns:a16="http://schemas.microsoft.com/office/drawing/2014/main" id="{F263A0B5-F8C4-4116-809F-78A768EA79A6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577582" y="557784"/>
            <a:ext cx="5130204" cy="5739187"/>
          </a:xfrm>
          <a:prstGeom prst="roundRect">
            <a:avLst>
              <a:gd name="adj" fmla="val 0"/>
            </a:avLst>
          </a:prstGeom>
          <a:solidFill>
            <a:srgbClr val="FFFFFF"/>
          </a:solidFill>
          <a:ln w="9525">
            <a:solidFill>
              <a:srgbClr val="C8CACA"/>
            </a:solidFill>
          </a:ln>
          <a:effectLst>
            <a:outerShdw blurRad="57150" dist="19050" dir="5400000" algn="t" rotWithShape="0">
              <a:prstClr val="black">
                <a:alpha val="6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4D09AEEF-8D29-2D48-A201-F37214AA855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6904709" y="1302690"/>
            <a:ext cx="4475531" cy="4249373"/>
          </a:xfrm>
          <a:prstGeom prst="rect">
            <a:avLst/>
          </a:prstGeom>
          <a:effectLst/>
        </p:spPr>
      </p:pic>
    </p:spTree>
    <p:extLst>
      <p:ext uri="{BB962C8B-B14F-4D97-AF65-F5344CB8AC3E}">
        <p14:creationId xmlns:p14="http://schemas.microsoft.com/office/powerpoint/2010/main" val="1855042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9</TotalTime>
  <Words>453</Words>
  <Application>Microsoft Office PowerPoint</Application>
  <PresentationFormat>Widescreen</PresentationFormat>
  <Paragraphs>42</Paragraphs>
  <Slides>8</Slides>
  <Notes>8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4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Office Theme</vt:lpstr>
      <vt:lpstr>PowerPoint-præsentation</vt:lpstr>
      <vt:lpstr>PowerPoint-præsentation</vt:lpstr>
      <vt:lpstr>PowerPoint-præsentation</vt:lpstr>
      <vt:lpstr>PowerPoint-præsentation</vt:lpstr>
      <vt:lpstr>PowerPoint-præsentation</vt:lpstr>
      <vt:lpstr>PowerPoint-præsentation</vt:lpstr>
      <vt:lpstr>PowerPoint-præsentation</vt:lpstr>
      <vt:lpstr>PowerPoint-præ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riia Bondarenko</dc:creator>
  <cp:lastModifiedBy>Axel Kornerup Hansen</cp:lastModifiedBy>
  <cp:revision>10</cp:revision>
  <dcterms:created xsi:type="dcterms:W3CDTF">2021-08-06T12:26:20Z</dcterms:created>
  <dcterms:modified xsi:type="dcterms:W3CDTF">2021-08-16T07:06:50Z</dcterms:modified>
</cp:coreProperties>
</file>